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6" d="100"/>
          <a:sy n="46" d="100"/>
        </p:scale>
        <p:origin x="78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4A05F116-C723-4AF0-A0D6-7C74A51E3B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xmlns="" id="{5743EB84-D43F-486E-A8A0-6973ECA5DF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F945D836-D1CD-4A5D-A4A0-1EE9689AC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8BBCBB74-154B-487C-9B1D-1F815D528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F2321E77-B751-4E49-8CE2-CD3360554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379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865556C6-5E80-44EE-ABE9-810E2CE49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xmlns="" id="{8E693DB5-648C-4399-BC6F-B7BBDA3055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9C5CE6E1-183B-4A53-9A4B-74A94A18C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C08FCF79-0429-4E8D-B0DC-A24E71895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39B153C1-86E7-46E7-93A5-56C206643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693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xmlns="" id="{3CB97FA0-D21D-417E-9A07-550978D475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xmlns="" id="{A04680E3-7B82-4048-B069-A36ADE14BD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416C9AA4-788D-4943-BE64-9B4050208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F6E7AF39-3406-4E09-B7DE-413978376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788EC631-18E4-44CB-BF15-A35BE73AE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813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6603BEB6-DFFE-4578-B7DA-39711C3929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E0B529E8-6AEE-42D2-9167-72E3E83C54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5A182111-8E6F-476A-9FAA-22886BD0E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7AE03B0C-CE36-48C2-BAEF-59CBBD702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62D7EAF6-29E4-436E-BC2C-473B72469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087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5D63E58B-E32D-4706-A4F9-F45717ABD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80452A6D-15B8-4108-9287-982042C0D9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48DCE350-DB01-408A-80F9-BE360B670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195CD7D1-0F40-403C-A51C-FFC1A6C77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6BE51627-529D-429D-A45B-313BCFEBD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7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17E1DA07-7FCB-474D-B31A-9A37DA51C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5602EDE4-644A-4FE3-A41C-2B33F2A94E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xmlns="" id="{72B4C278-DB7B-4857-B516-43A446FE9F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12ECD426-CAA4-43D1-9882-AC1E6C9D0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3DF94122-954C-4897-8A63-07226FDED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DE3E58AF-94A7-4235-8FB4-AE3F554C2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8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F72C0EFF-06A0-42CA-8818-2BC332676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03277682-12A9-4068-8D64-CADC292B1C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xmlns="" id="{104FCB59-B747-46CC-8094-EDB6581F62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xmlns="" id="{1DB18FF5-A256-4DAF-998B-AF1078E173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xmlns="" id="{960CCD83-78FA-4CC5-A799-BCCDBE896E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xmlns="" id="{53359876-8B54-4D01-A7B3-38500F881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xmlns="" id="{9E924237-4B58-470A-B6A4-8B0EE7844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xmlns="" id="{2D7D2C67-1D4B-4B8A-8550-2E61D0016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520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0FD16680-9C19-43C5-8969-F495FE446C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xmlns="" id="{FD96303B-B2EE-4702-8E96-BFC0BCD6E1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xmlns="" id="{B93FE26A-FB9B-47F1-B298-30F252640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xmlns="" id="{7A8F12B5-DF5A-4779-860D-5D7501B61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006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xmlns="" id="{D8EB68C9-7928-434D-8F0B-863B8960E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xmlns="" id="{0036EB87-E7E0-4F99-A746-74676CD09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xmlns="" id="{AC7D9880-6833-4262-ADB5-E6E85B0FE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937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73927342-7AD1-4A1F-82E9-A2F091013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xmlns="" id="{8BBE0917-5CA0-4B70-B56B-B903B2B81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xmlns="" id="{5B370349-93AC-47E1-98CF-51A1721507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82933978-E7A4-46EB-A391-B35A0519B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16B4C62A-AFC4-49E7-8C91-7D0FB3A2F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BFA7E235-163C-4DC7-853A-A51AF2FD02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692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xmlns="" id="{8658E6AB-7B64-4635-A232-CA41A24498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xmlns="" id="{A03551D7-7D4F-4AE9-8943-520555788B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xmlns="" id="{14094DDB-FEF2-4A53-B652-87339674D0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xmlns="" id="{1E52CE60-9405-4436-8718-9A8F9EE6F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xmlns="" id="{38F2A229-B453-4216-B90B-27E210AAB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xmlns="" id="{A1987CF4-0ABE-4DB6-9CBE-2227ECF4B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862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xmlns="" id="{BF711E19-6244-4C3F-B157-1D137FC71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/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xmlns="" id="{C7C77417-61DC-4CE1-AD23-7D860D7B95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/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xmlns="" id="{E34C5DB4-E206-4CE9-B145-83203C039F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61D1C-E5F5-4489-B01E-569D8C7A2A25}" type="datetimeFigureOut">
              <a:rPr lang="en-US" smtClean="0"/>
              <a:t>5/9/2024</a:t>
            </a:fld>
            <a:endParaRPr lang="en-US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xmlns="" id="{61E0BC4C-04E2-492E-926E-D3CEB4C51F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xmlns="" id="{81B50F65-24C7-406B-8C55-FC110719D5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9CD2F-DE2F-464F-92AA-DDA719DCD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404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a 8"/>
          <p:cNvGrpSpPr/>
          <p:nvPr/>
        </p:nvGrpSpPr>
        <p:grpSpPr>
          <a:xfrm>
            <a:off x="533218" y="1542033"/>
            <a:ext cx="10093102" cy="3217153"/>
            <a:chOff x="536371" y="1573564"/>
            <a:chExt cx="10093102" cy="3217153"/>
          </a:xfrm>
        </p:grpSpPr>
        <p:pic>
          <p:nvPicPr>
            <p:cNvPr id="2" name="Obraz 1">
              <a:extLst>
                <a:ext uri="{FF2B5EF4-FFF2-40B4-BE49-F238E27FC236}">
                  <a16:creationId xmlns:a16="http://schemas.microsoft.com/office/drawing/2014/main" xmlns="" id="{880D75CD-308D-4639-91B8-E3A626566A4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843908" y="2463431"/>
              <a:ext cx="1785565" cy="2249094"/>
            </a:xfrm>
            <a:prstGeom prst="rect">
              <a:avLst/>
            </a:prstGeom>
          </p:spPr>
        </p:pic>
        <p:pic>
          <p:nvPicPr>
            <p:cNvPr id="3" name="Obraz 2">
              <a:extLst>
                <a:ext uri="{FF2B5EF4-FFF2-40B4-BE49-F238E27FC236}">
                  <a16:creationId xmlns:a16="http://schemas.microsoft.com/office/drawing/2014/main" xmlns="" id="{C0944ED5-8A44-4535-855C-F39040ABD04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966725" y="2465735"/>
              <a:ext cx="1785564" cy="2249092"/>
            </a:xfrm>
            <a:prstGeom prst="rect">
              <a:avLst/>
            </a:prstGeom>
          </p:spPr>
        </p:pic>
        <p:sp>
          <p:nvSpPr>
            <p:cNvPr id="4" name="pole tekstowe 3">
              <a:extLst>
                <a:ext uri="{FF2B5EF4-FFF2-40B4-BE49-F238E27FC236}">
                  <a16:creationId xmlns:a16="http://schemas.microsoft.com/office/drawing/2014/main" xmlns="" id="{75750786-F492-472F-BF1D-95595FFD86C7}"/>
                </a:ext>
              </a:extLst>
            </p:cNvPr>
            <p:cNvSpPr txBox="1"/>
            <p:nvPr/>
          </p:nvSpPr>
          <p:spPr>
            <a:xfrm>
              <a:off x="5111197" y="2129526"/>
              <a:ext cx="9733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4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ac08hb6</a:t>
              </a:r>
              <a:endPara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pole tekstowe 4">
              <a:extLst>
                <a:ext uri="{FF2B5EF4-FFF2-40B4-BE49-F238E27FC236}">
                  <a16:creationId xmlns:a16="http://schemas.microsoft.com/office/drawing/2014/main" xmlns="" id="{89873E66-7822-45B9-9260-A2B0C1CDE36C}"/>
                </a:ext>
              </a:extLst>
            </p:cNvPr>
            <p:cNvSpPr txBox="1"/>
            <p:nvPr/>
          </p:nvSpPr>
          <p:spPr>
            <a:xfrm>
              <a:off x="3945674" y="2146945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Obraz 5">
              <a:extLst>
                <a:ext uri="{FF2B5EF4-FFF2-40B4-BE49-F238E27FC236}">
                  <a16:creationId xmlns:a16="http://schemas.microsoft.com/office/drawing/2014/main" xmlns="" id="{4C7425B6-9638-48C3-8BB5-535096C8CE1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83795" y="2465733"/>
              <a:ext cx="3115980" cy="2249094"/>
            </a:xfrm>
            <a:prstGeom prst="rect">
              <a:avLst/>
            </a:prstGeom>
          </p:spPr>
        </p:pic>
        <p:sp>
          <p:nvSpPr>
            <p:cNvPr id="7" name="pole tekstowe 6">
              <a:extLst>
                <a:ext uri="{FF2B5EF4-FFF2-40B4-BE49-F238E27FC236}">
                  <a16:creationId xmlns:a16="http://schemas.microsoft.com/office/drawing/2014/main" xmlns="" id="{87C2AEEB-DF65-42B9-B910-D34403D2697B}"/>
                </a:ext>
              </a:extLst>
            </p:cNvPr>
            <p:cNvSpPr txBox="1"/>
            <p:nvPr/>
          </p:nvSpPr>
          <p:spPr>
            <a:xfrm>
              <a:off x="9267436" y="2129525"/>
              <a:ext cx="9733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4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ac08hb6</a:t>
              </a:r>
              <a:endPara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pole tekstowe 9">
              <a:extLst>
                <a:ext uri="{FF2B5EF4-FFF2-40B4-BE49-F238E27FC236}">
                  <a16:creationId xmlns:a16="http://schemas.microsoft.com/office/drawing/2014/main" xmlns="" id="{A3BE961F-F010-4C5B-86E8-172C9D37133D}"/>
                </a:ext>
              </a:extLst>
            </p:cNvPr>
            <p:cNvSpPr txBox="1"/>
            <p:nvPr/>
          </p:nvSpPr>
          <p:spPr>
            <a:xfrm>
              <a:off x="8176898" y="1573564"/>
              <a:ext cx="13340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eaf</a:t>
              </a:r>
              <a:r>
                <a:rPr lang="pl-PL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l-PL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ructure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pole tekstowe 10">
              <a:extLst>
                <a:ext uri="{FF2B5EF4-FFF2-40B4-BE49-F238E27FC236}">
                  <a16:creationId xmlns:a16="http://schemas.microsoft.com/office/drawing/2014/main" xmlns="" id="{0B85C8D6-1F3E-4953-BA28-F64C9A9ADCA3}"/>
                </a:ext>
              </a:extLst>
            </p:cNvPr>
            <p:cNvSpPr txBox="1"/>
            <p:nvPr/>
          </p:nvSpPr>
          <p:spPr>
            <a:xfrm>
              <a:off x="4409262" y="1573564"/>
              <a:ext cx="73930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s</a:t>
              </a:r>
              <a:r>
                <a:rPr lang="pl-PL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" name="Obraz 16">
              <a:extLst>
                <a:ext uri="{FF2B5EF4-FFF2-40B4-BE49-F238E27FC236}">
                  <a16:creationId xmlns:a16="http://schemas.microsoft.com/office/drawing/2014/main" xmlns="" id="{D2E26A62-4D38-465E-85CA-ACB6394FB73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525321" y="2146945"/>
              <a:ext cx="493819" cy="377985"/>
            </a:xfrm>
            <a:prstGeom prst="rect">
              <a:avLst/>
            </a:prstGeom>
          </p:spPr>
        </p:pic>
        <p:pic>
          <p:nvPicPr>
            <p:cNvPr id="22" name="Obraz 21">
              <a:extLst>
                <a:ext uri="{FF2B5EF4-FFF2-40B4-BE49-F238E27FC236}">
                  <a16:creationId xmlns:a16="http://schemas.microsoft.com/office/drawing/2014/main" xmlns="" id="{DBD3B9CA-5F31-4DF7-BBA2-4D441707CF2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6371" y="2385238"/>
              <a:ext cx="2311953" cy="2405479"/>
            </a:xfrm>
            <a:prstGeom prst="rect">
              <a:avLst/>
            </a:prstGeom>
          </p:spPr>
        </p:pic>
        <p:sp>
          <p:nvSpPr>
            <p:cNvPr id="25" name="pole tekstowe 24">
              <a:extLst>
                <a:ext uri="{FF2B5EF4-FFF2-40B4-BE49-F238E27FC236}">
                  <a16:creationId xmlns:a16="http://schemas.microsoft.com/office/drawing/2014/main" xmlns="" id="{F14AFDD3-5EE1-416D-A369-AC4BA377D57E}"/>
                </a:ext>
              </a:extLst>
            </p:cNvPr>
            <p:cNvSpPr txBox="1"/>
            <p:nvPr/>
          </p:nvSpPr>
          <p:spPr>
            <a:xfrm>
              <a:off x="1093017" y="1578634"/>
              <a:ext cx="9845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edlings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pole tekstowe 25">
              <a:extLst>
                <a:ext uri="{FF2B5EF4-FFF2-40B4-BE49-F238E27FC236}">
                  <a16:creationId xmlns:a16="http://schemas.microsoft.com/office/drawing/2014/main" xmlns="" id="{6206053A-6A0C-4161-BDFD-4FC4BA04BD97}"/>
                </a:ext>
              </a:extLst>
            </p:cNvPr>
            <p:cNvSpPr txBox="1"/>
            <p:nvPr/>
          </p:nvSpPr>
          <p:spPr>
            <a:xfrm>
              <a:off x="1755264" y="2150414"/>
              <a:ext cx="9733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4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ac08hb6</a:t>
              </a:r>
              <a:endParaRPr lang="en-US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pole tekstowe 27">
              <a:extLst>
                <a:ext uri="{FF2B5EF4-FFF2-40B4-BE49-F238E27FC236}">
                  <a16:creationId xmlns:a16="http://schemas.microsoft.com/office/drawing/2014/main" xmlns="" id="{4D52E449-7F65-47BB-A602-957821AC25EA}"/>
                </a:ext>
              </a:extLst>
            </p:cNvPr>
            <p:cNvSpPr txBox="1"/>
            <p:nvPr/>
          </p:nvSpPr>
          <p:spPr>
            <a:xfrm>
              <a:off x="861223" y="2158936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074429" y="477982"/>
            <a:ext cx="74333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3. Phenotypic characterization of WT and </a:t>
            </a:r>
            <a:r>
              <a:rPr lang="en-US" i="1" dirty="0"/>
              <a:t>bnac08hb6</a:t>
            </a:r>
            <a:r>
              <a:rPr lang="en-US" dirty="0"/>
              <a:t> mutant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58704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0</TotalTime>
  <Words>20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N.Żyła</dc:creator>
  <cp:lastModifiedBy>Lakshmi S</cp:lastModifiedBy>
  <cp:revision>20</cp:revision>
  <dcterms:created xsi:type="dcterms:W3CDTF">2023-08-21T09:49:32Z</dcterms:created>
  <dcterms:modified xsi:type="dcterms:W3CDTF">2024-05-09T06:50:10Z</dcterms:modified>
</cp:coreProperties>
</file>